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0" d="100"/>
          <a:sy n="120" d="100"/>
        </p:scale>
        <p:origin x="600" y="-34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99D1C-EEAD-4629-ABBE-7C3C1A216EFB}" type="datetimeFigureOut">
              <a:rPr lang="zh-CN" altLang="en-US" smtClean="0"/>
              <a:t>2022/1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F2598-E57A-42A2-9E63-4EEB03F4FA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07984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99D1C-EEAD-4629-ABBE-7C3C1A216EFB}" type="datetimeFigureOut">
              <a:rPr lang="zh-CN" altLang="en-US" smtClean="0"/>
              <a:t>2022/1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F2598-E57A-42A2-9E63-4EEB03F4FA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8145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99D1C-EEAD-4629-ABBE-7C3C1A216EFB}" type="datetimeFigureOut">
              <a:rPr lang="zh-CN" altLang="en-US" smtClean="0"/>
              <a:t>2022/1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F2598-E57A-42A2-9E63-4EEB03F4FA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33939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99D1C-EEAD-4629-ABBE-7C3C1A216EFB}" type="datetimeFigureOut">
              <a:rPr lang="zh-CN" altLang="en-US" smtClean="0"/>
              <a:t>2022/1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F2598-E57A-42A2-9E63-4EEB03F4FA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3660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99D1C-EEAD-4629-ABBE-7C3C1A216EFB}" type="datetimeFigureOut">
              <a:rPr lang="zh-CN" altLang="en-US" smtClean="0"/>
              <a:t>2022/1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F2598-E57A-42A2-9E63-4EEB03F4FA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08733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99D1C-EEAD-4629-ABBE-7C3C1A216EFB}" type="datetimeFigureOut">
              <a:rPr lang="zh-CN" altLang="en-US" smtClean="0"/>
              <a:t>2022/11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F2598-E57A-42A2-9E63-4EEB03F4FA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869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99D1C-EEAD-4629-ABBE-7C3C1A216EFB}" type="datetimeFigureOut">
              <a:rPr lang="zh-CN" altLang="en-US" smtClean="0"/>
              <a:t>2022/11/1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F2598-E57A-42A2-9E63-4EEB03F4FA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66433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99D1C-EEAD-4629-ABBE-7C3C1A216EFB}" type="datetimeFigureOut">
              <a:rPr lang="zh-CN" altLang="en-US" smtClean="0"/>
              <a:t>2022/11/1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F2598-E57A-42A2-9E63-4EEB03F4FA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07146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99D1C-EEAD-4629-ABBE-7C3C1A216EFB}" type="datetimeFigureOut">
              <a:rPr lang="zh-CN" altLang="en-US" smtClean="0"/>
              <a:t>2022/11/1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F2598-E57A-42A2-9E63-4EEB03F4FA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74494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99D1C-EEAD-4629-ABBE-7C3C1A216EFB}" type="datetimeFigureOut">
              <a:rPr lang="zh-CN" altLang="en-US" smtClean="0"/>
              <a:t>2022/11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F2598-E57A-42A2-9E63-4EEB03F4FA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50011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99D1C-EEAD-4629-ABBE-7C3C1A216EFB}" type="datetimeFigureOut">
              <a:rPr lang="zh-CN" altLang="en-US" smtClean="0"/>
              <a:t>2022/11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F2598-E57A-42A2-9E63-4EEB03F4FA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91661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899D1C-EEAD-4629-ABBE-7C3C1A216EFB}" type="datetimeFigureOut">
              <a:rPr lang="zh-CN" altLang="en-US" smtClean="0"/>
              <a:t>2022/1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8F2598-E57A-42A2-9E63-4EEB03F4FA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37090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053" y="3151385"/>
            <a:ext cx="6341364" cy="2837688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340243" y="6459278"/>
            <a:ext cx="632105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ub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ncRNAs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validation in TCGA-PRAD data. The expression levels of the 8 hub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ncRNAs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adjacent normal and tumor tissues of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Ca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86951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27</Words>
  <Application>Microsoft Office PowerPoint</Application>
  <PresentationFormat>A4 纸张(210x297 毫米)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UANG WEIHUA</dc:creator>
  <cp:lastModifiedBy>HUANG WEIHUA</cp:lastModifiedBy>
  <cp:revision>1</cp:revision>
  <dcterms:created xsi:type="dcterms:W3CDTF">2022-11-18T00:54:28Z</dcterms:created>
  <dcterms:modified xsi:type="dcterms:W3CDTF">2022-11-18T00:56:44Z</dcterms:modified>
</cp:coreProperties>
</file>